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2" r:id="rId3"/>
  </p:sldIdLst>
  <p:sldSz cx="9144000" cy="1371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2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41" d="100"/>
          <a:sy n="41" d="100"/>
        </p:scale>
        <p:origin x="1500" y="-426"/>
      </p:cViewPr>
      <p:guideLst>
        <p:guide orient="horz" pos="43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4260851"/>
            <a:ext cx="7772400" cy="294005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7772400"/>
            <a:ext cx="6400800" cy="35052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699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290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549277"/>
            <a:ext cx="2057400" cy="117030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549277"/>
            <a:ext cx="6019800" cy="117030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157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562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8813801"/>
            <a:ext cx="7772400" cy="272415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5813427"/>
            <a:ext cx="7772400" cy="30003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85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3200401"/>
            <a:ext cx="4038600" cy="905192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3200401"/>
            <a:ext cx="4038600" cy="905192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141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3070226"/>
            <a:ext cx="4040188" cy="12795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4349750"/>
            <a:ext cx="4040188" cy="790257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3070226"/>
            <a:ext cx="4041775" cy="12795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4349750"/>
            <a:ext cx="4041775" cy="790257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070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97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891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546100"/>
            <a:ext cx="3008313" cy="23241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546101"/>
            <a:ext cx="5111750" cy="1170622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2870201"/>
            <a:ext cx="3008313" cy="93821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154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9601200"/>
            <a:ext cx="5486400" cy="113347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1225550"/>
            <a:ext cx="5486400" cy="8229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10734676"/>
            <a:ext cx="5486400" cy="160972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818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549276"/>
            <a:ext cx="8229600" cy="2286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3200401"/>
            <a:ext cx="8229600" cy="90519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12712701"/>
            <a:ext cx="21336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56C7B-2540-4FF9-A04B-A41C9263F6E5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12712701"/>
            <a:ext cx="28956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12712701"/>
            <a:ext cx="21336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20BC7E-9A37-4865-A06B-A3CCC602B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872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jpe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png"/><Relationship Id="rId10" Type="http://schemas.openxmlformats.org/officeDocument/2006/relationships/image" Target="../media/image6.jpeg"/><Relationship Id="rId4" Type="http://schemas.microsoft.com/office/2007/relationships/hdphoto" Target="../media/hdphoto1.wdp"/><Relationship Id="rId9" Type="http://schemas.microsoft.com/office/2007/relationships/hdphoto" Target="../media/hdphoto3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187624" y="1529408"/>
            <a:ext cx="7488832" cy="7683480"/>
            <a:chOff x="860872" y="-73516"/>
            <a:chExt cx="8883719" cy="8168253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89" t="23540" r="31147" b="9996"/>
            <a:stretch/>
          </p:blipFill>
          <p:spPr bwMode="auto">
            <a:xfrm>
              <a:off x="860872" y="-73515"/>
              <a:ext cx="3846942" cy="37684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5" descr="C:\Users\Sonia&amp;Azad\Downloads\1708157352743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41731" y="-73516"/>
              <a:ext cx="5002860" cy="208856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" name="Picture 2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345" b="9070"/>
            <a:stretch/>
          </p:blipFill>
          <p:spPr bwMode="auto">
            <a:xfrm>
              <a:off x="4737575" y="2050935"/>
              <a:ext cx="4998874" cy="19762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3" descr="C:\Users\Sonia&amp;Azad\Downloads\1708505691510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822" r="3150" b="17178"/>
            <a:stretch/>
          </p:blipFill>
          <p:spPr bwMode="auto">
            <a:xfrm>
              <a:off x="4739682" y="4063073"/>
              <a:ext cx="5002858" cy="186981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2" descr="C:\Users\Sonia&amp;Azad\Downloads\1708505818621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09" r="6364" b="45071"/>
            <a:stretch/>
          </p:blipFill>
          <p:spPr bwMode="auto">
            <a:xfrm>
              <a:off x="4737575" y="5948872"/>
              <a:ext cx="5007016" cy="21458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2" descr="C:\Users\Sonia&amp;Azad\Downloads\1708505691504.jpg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64" t="15709" r="43454" b="19193"/>
            <a:stretch/>
          </p:blipFill>
          <p:spPr bwMode="auto">
            <a:xfrm>
              <a:off x="860872" y="3729853"/>
              <a:ext cx="3855144" cy="433880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8" name="TextBox 7"/>
          <p:cNvSpPr txBox="1"/>
          <p:nvPr/>
        </p:nvSpPr>
        <p:spPr>
          <a:xfrm>
            <a:off x="791580" y="10170368"/>
            <a:ext cx="787801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: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me experimental challenge for PC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ed DNA fragments in size (780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ing specific primers for th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l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izogenes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rbascu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iry root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NA in the study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689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163938" y="1457400"/>
            <a:ext cx="6384075" cy="7488833"/>
            <a:chOff x="1403648" y="1457400"/>
            <a:chExt cx="6384075" cy="7488833"/>
          </a:xfrm>
        </p:grpSpPr>
        <p:pic>
          <p:nvPicPr>
            <p:cNvPr id="5122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498" t="25091" r="31391" b="32468"/>
            <a:stretch/>
          </p:blipFill>
          <p:spPr bwMode="auto">
            <a:xfrm>
              <a:off x="1403648" y="1457400"/>
              <a:ext cx="6384075" cy="34212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2198126" y="2024573"/>
              <a:ext cx="403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S1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680463" y="2037999"/>
              <a:ext cx="403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S2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156805" y="2037999"/>
              <a:ext cx="403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S3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587674" y="2047632"/>
              <a:ext cx="403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S4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990879" y="2037999"/>
              <a:ext cx="403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S5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394084" y="2043625"/>
              <a:ext cx="403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S6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98088" y="2047632"/>
              <a:ext cx="403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S7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301293" y="2049069"/>
              <a:ext cx="403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S8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704498" y="2050507"/>
              <a:ext cx="4032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S9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107703" y="2050507"/>
              <a:ext cx="6641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S10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645309" y="2078746"/>
              <a:ext cx="6641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S11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098903" y="2080183"/>
              <a:ext cx="6641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</a:rPr>
                <a:t>C+</a:t>
              </a:r>
              <a:endParaRPr lang="en-US" sz="1600" dirty="0">
                <a:solidFill>
                  <a:srgbClr val="FFFF00"/>
                </a:solidFill>
              </a:endParaRPr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1403648" y="4906848"/>
              <a:ext cx="6384075" cy="4039385"/>
              <a:chOff x="2208877" y="764704"/>
              <a:chExt cx="4303713" cy="4680519"/>
            </a:xfrm>
          </p:grpSpPr>
          <p:pic>
            <p:nvPicPr>
              <p:cNvPr id="18" name="Picture 17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08877" y="764704"/>
                <a:ext cx="4303713" cy="468051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2243126" y="764704"/>
                <a:ext cx="576064" cy="3922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FFFF00"/>
                    </a:solidFill>
                  </a:rPr>
                  <a:t>S</a:t>
                </a:r>
                <a:r>
                  <a:rPr lang="en-US" sz="1600" dirty="0">
                    <a:solidFill>
                      <a:srgbClr val="FFFF00"/>
                    </a:solidFill>
                  </a:rPr>
                  <a:t>12</a:t>
                </a:r>
                <a:endParaRPr lang="en-US" sz="1600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812053" y="781264"/>
                <a:ext cx="576064" cy="3922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FFFF00"/>
                    </a:solidFill>
                  </a:rPr>
                  <a:t>S13</a:t>
                </a:r>
                <a:endParaRPr lang="en-US" sz="1600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315511" y="764704"/>
                <a:ext cx="576064" cy="3922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FFFF00"/>
                    </a:solidFill>
                  </a:rPr>
                  <a:t>S14</a:t>
                </a:r>
                <a:endParaRPr lang="en-US" sz="1600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809045" y="788524"/>
                <a:ext cx="576064" cy="3922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FFFF00"/>
                    </a:solidFill>
                  </a:rPr>
                  <a:t>S15</a:t>
                </a:r>
                <a:endParaRPr lang="en-US" sz="1600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360733" y="764704"/>
                <a:ext cx="576064" cy="3922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FFFF00"/>
                    </a:solidFill>
                  </a:rPr>
                  <a:t>C-</a:t>
                </a:r>
                <a:endParaRPr lang="en-US" sz="1600" dirty="0">
                  <a:solidFill>
                    <a:srgbClr val="FFFF00"/>
                  </a:solidFill>
                </a:endParaRPr>
              </a:p>
            </p:txBody>
          </p:sp>
        </p:grpSp>
      </p:grpSp>
      <p:sp>
        <p:nvSpPr>
          <p:cNvPr id="24" name="TextBox 23"/>
          <p:cNvSpPr txBox="1"/>
          <p:nvPr/>
        </p:nvSpPr>
        <p:spPr>
          <a:xfrm>
            <a:off x="539552" y="9409968"/>
            <a:ext cx="763284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: PCR amplified DNA fragments in size (780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ing specific primers for th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l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izogenes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rbascu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iry root DNA. M: 100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Ladder, S1-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5: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iry root lines, C-: Adventitious root raised from non-transformed explant as a negative control, C+: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izogenes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smid as a positive control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548333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8</TotalTime>
  <Words>125</Words>
  <Application>Microsoft Office PowerPoint</Application>
  <PresentationFormat>Custom</PresentationFormat>
  <Paragraphs>2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ia&amp;Azad</dc:creator>
  <cp:lastModifiedBy>S.A</cp:lastModifiedBy>
  <cp:revision>19</cp:revision>
  <dcterms:created xsi:type="dcterms:W3CDTF">2024-02-21T08:23:04Z</dcterms:created>
  <dcterms:modified xsi:type="dcterms:W3CDTF">2024-02-23T16:05:34Z</dcterms:modified>
</cp:coreProperties>
</file>